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8" r:id="rId3"/>
    <p:sldId id="256" r:id="rId4"/>
    <p:sldId id="257" r:id="rId5"/>
    <p:sldId id="274" r:id="rId6"/>
    <p:sldId id="276" r:id="rId7"/>
    <p:sldId id="258" r:id="rId8"/>
    <p:sldId id="279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2" Type="http://schemas.openxmlformats.org/officeDocument/2006/relationships/tableStyles" Target="tableStyles.xml"/><Relationship Id="rId11" Type="http://schemas.openxmlformats.org/officeDocument/2006/relationships/viewProps" Target="viewProps.xml"/><Relationship Id="rId10" Type="http://schemas.openxmlformats.org/officeDocument/2006/relationships/presProps" Target="presProp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3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4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5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5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817370" y="1777365"/>
            <a:ext cx="8557260" cy="192913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文本框 5"/>
          <p:cNvSpPr txBox="1"/>
          <p:nvPr/>
        </p:nvSpPr>
        <p:spPr>
          <a:xfrm>
            <a:off x="2423795" y="3814445"/>
            <a:ext cx="734441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1400">
                <a:latin typeface="Times New Roman" panose="02020603050405020304" charset="0"/>
                <a:cs typeface="Times New Roman" panose="02020603050405020304" charset="0"/>
              </a:rPr>
              <a:t>Supplementary Figure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.</a:t>
            </a:r>
            <a:r>
              <a:rPr lang="zh-CN" altLang="en-US" sz="1400">
                <a:latin typeface="Times New Roman" panose="02020603050405020304" charset="0"/>
                <a:cs typeface="Times New Roman" panose="02020603050405020304" charset="0"/>
              </a:rPr>
              <a:t>1 GC-MS of lauric acid in susceptible and resistant soybeans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.(A)susceptible Williams;(B).resistant Williams 82.</a:t>
            </a:r>
            <a:endParaRPr lang="en-US" altLang="zh-CN" sz="140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00" name="文本框 99"/>
          <p:cNvSpPr txBox="1"/>
          <p:nvPr/>
        </p:nvSpPr>
        <p:spPr>
          <a:xfrm>
            <a:off x="1842135" y="1304290"/>
            <a:ext cx="8507730" cy="30670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sz="1400" b="0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</a:rPr>
              <a:t>Supplementary Table.1 </a:t>
            </a:r>
            <a:r>
              <a:rPr lang="en-US" sz="1400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Effect of lauric acid on h</a:t>
            </a:r>
            <a:r>
              <a:rPr lang="en-US" sz="1400" b="0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</a:rPr>
              <a:t>ypha diameter of 4 species </a:t>
            </a:r>
            <a:r>
              <a:rPr lang="en-US" sz="1400" b="0" i="1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</a:rPr>
              <a:t>Phytophthora sojae</a:t>
            </a:r>
            <a:r>
              <a:rPr lang="en-US" sz="1400" b="0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</a:rPr>
              <a:t> </a:t>
            </a:r>
            <a:r>
              <a:rPr lang="en-US" sz="1400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mycelial growth.</a:t>
            </a:r>
            <a:endParaRPr lang="en-US" sz="1400" b="0">
              <a:solidFill>
                <a:srgbClr val="333333"/>
              </a:solidFill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graphicFrame>
        <p:nvGraphicFramePr>
          <p:cNvPr id="5" name="表格 4"/>
          <p:cNvGraphicFramePr/>
          <p:nvPr>
            <p:custDataLst>
              <p:tags r:id="rId1"/>
            </p:custDataLst>
          </p:nvPr>
        </p:nvGraphicFramePr>
        <p:xfrm>
          <a:off x="2069148" y="1773555"/>
          <a:ext cx="7461885" cy="24771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34135"/>
                <a:gridCol w="1021080"/>
                <a:gridCol w="1021715"/>
                <a:gridCol w="1021080"/>
                <a:gridCol w="1021715"/>
                <a:gridCol w="1021715"/>
                <a:gridCol w="1020445"/>
              </a:tblGrid>
              <a:tr h="392430">
                <a:tc rowSpan="2"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i="1">
                          <a:solidFill>
                            <a:srgbClr val="333333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sym typeface="+mn-ea"/>
                        </a:rPr>
                        <a:t>Phytophthora soja</a:t>
                      </a:r>
                      <a:r>
                        <a:rPr lang="en-US" sz="1200" i="1">
                          <a:solidFill>
                            <a:srgbClr val="333333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  <a:sym typeface="+mn-ea"/>
                        </a:rPr>
                        <a:t>e</a:t>
                      </a:r>
                      <a:endParaRPr lang="zh-CN" altLang="en-US" sz="1200" b="0">
                        <a:solidFill>
                          <a:srgbClr val="FF0000"/>
                        </a:solidFill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6"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Mycelial growth (mm) at different concentrations of l</a:t>
                      </a:r>
                      <a:r>
                        <a:rPr lang="en-US" sz="1200">
                          <a:solidFill>
                            <a:srgbClr val="333333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sym typeface="+mn-ea"/>
                        </a:rPr>
                        <a:t>auric acid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</a:tr>
              <a:tr h="384175">
                <a:tc vMerge="1"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0 mM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5 </a:t>
                      </a:r>
                      <a:r>
                        <a:rPr lang="en-US" sz="120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  <a:sym typeface="+mn-ea"/>
                        </a:rPr>
                        <a:t>mM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alt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1.0</a:t>
                      </a:r>
                      <a:r>
                        <a:rPr lang="en-US" sz="120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  <a:sym typeface="+mn-ea"/>
                        </a:rPr>
                        <a:t> </a:t>
                      </a:r>
                      <a:r>
                        <a:rPr lang="en-US" sz="120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  <a:sym typeface="+mn-ea"/>
                        </a:rPr>
                        <a:t>mM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alt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1.5</a:t>
                      </a:r>
                      <a:r>
                        <a:rPr lang="en-US" sz="120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  <a:sym typeface="+mn-ea"/>
                        </a:rPr>
                        <a:t> </a:t>
                      </a:r>
                      <a:r>
                        <a:rPr lang="en-US" sz="120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  <a:sym typeface="+mn-ea"/>
                        </a:rPr>
                        <a:t>mM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alt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2.0</a:t>
                      </a:r>
                      <a:r>
                        <a:rPr lang="en-US" sz="120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  <a:sym typeface="+mn-ea"/>
                        </a:rPr>
                        <a:t> </a:t>
                      </a:r>
                      <a:r>
                        <a:rPr lang="en-US" sz="120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  <a:sym typeface="+mn-ea"/>
                        </a:rPr>
                        <a:t>mM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alt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2.5</a:t>
                      </a:r>
                      <a:r>
                        <a:rPr lang="en-US" sz="120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  <a:sym typeface="+mn-ea"/>
                        </a:rPr>
                        <a:t> </a:t>
                      </a:r>
                      <a:r>
                        <a:rPr lang="en-US" sz="120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  <a:sym typeface="+mn-ea"/>
                        </a:rPr>
                        <a:t>mM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4180"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R2</a:t>
                      </a:r>
                      <a:endParaRPr lang="zh-CN" alt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7.37±0.45 b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26.27±0.37 c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23.87±0.56 c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23.40±0.79 c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19.80±0.36 c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20.17±0.33 c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6085"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R7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63.50±0.59 a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43.90±0.62 b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36.33±0.98 a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28.53±0.26 b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27.47±0.54 a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27.27±0.12 a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4815"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R17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34.73±0.37 c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24.93±0.54 c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23.10±0.22 c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23.40±1.14 c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21.73±0.68 b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19.93±0.57 c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5450"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R19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60.13±1.33 a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46.10±0.65 a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34.63±0.33 b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32.43±0.34 a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22.30±0.71 b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22.33±1.17 b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4" name="文本框 3"/>
          <p:cNvSpPr txBox="1"/>
          <p:nvPr/>
        </p:nvSpPr>
        <p:spPr>
          <a:xfrm>
            <a:off x="1842135" y="4413250"/>
            <a:ext cx="8134350" cy="4603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Note: Values within columns followed by the same letter for each parameter are not significantly different from each other based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on ANOVA and Fisher’s protected LSD test (p &lt; 0.05).</a:t>
            </a:r>
            <a:endParaRPr lang="zh-CN" altLang="en-US" sz="120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文本框 4"/>
          <p:cNvSpPr txBox="1"/>
          <p:nvPr/>
        </p:nvSpPr>
        <p:spPr>
          <a:xfrm>
            <a:off x="1802765" y="1210945"/>
            <a:ext cx="8587105" cy="30670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sz="1400" b="0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</a:rPr>
              <a:t>Supplementary Table.2 </a:t>
            </a:r>
            <a:r>
              <a:rPr lang="en-US" sz="1400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Effect of lauric acid and its derivatives on </a:t>
            </a:r>
            <a:r>
              <a:rPr lang="en-US" sz="1400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 </a:t>
            </a:r>
            <a:r>
              <a:rPr lang="en-US" sz="1400" i="1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Phytophthora sojae</a:t>
            </a:r>
            <a:r>
              <a:rPr lang="zh-CN" altLang="en-US" sz="1400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（</a:t>
            </a:r>
            <a:r>
              <a:rPr lang="en-US" altLang="zh-CN" sz="1400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R2</a:t>
            </a:r>
            <a:r>
              <a:rPr lang="zh-CN" altLang="en-US" sz="1400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）</a:t>
            </a:r>
            <a:r>
              <a:rPr lang="en-US" sz="1400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 </a:t>
            </a:r>
            <a:r>
              <a:rPr lang="en-US" sz="1400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mycelial growth.</a:t>
            </a:r>
            <a:endParaRPr lang="zh-CN" altLang="en-US" sz="1400" b="0">
              <a:solidFill>
                <a:srgbClr val="333333"/>
              </a:solidFill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graphicFrame>
        <p:nvGraphicFramePr>
          <p:cNvPr id="2" name="表格 1"/>
          <p:cNvGraphicFramePr/>
          <p:nvPr>
            <p:custDataLst>
              <p:tags r:id="rId1"/>
            </p:custDataLst>
          </p:nvPr>
        </p:nvGraphicFramePr>
        <p:xfrm>
          <a:off x="2028190" y="1738630"/>
          <a:ext cx="7994015" cy="245935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429385"/>
                <a:gridCol w="1093470"/>
                <a:gridCol w="1095375"/>
                <a:gridCol w="1094105"/>
                <a:gridCol w="1093470"/>
                <a:gridCol w="1095375"/>
                <a:gridCol w="1092835"/>
              </a:tblGrid>
              <a:tr h="389890">
                <a:tc row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Compound</a:t>
                      </a:r>
                      <a:endParaRPr lang="en-US" altLang="zh-CN" sz="1200">
                        <a:solidFill>
                          <a:srgbClr val="FF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6"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Mycelial growth (mm) at different concentrations of l</a:t>
                      </a:r>
                      <a:r>
                        <a:rPr lang="en-US" sz="1200">
                          <a:solidFill>
                            <a:srgbClr val="333333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sym typeface="+mn-ea"/>
                        </a:rPr>
                        <a:t>auric acid and its derivatives</a:t>
                      </a:r>
                      <a:endParaRPr lang="en-US" altLang="en-US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</a:tr>
              <a:tr h="380365">
                <a:tc vMerge="1"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0 mM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5 </a:t>
                      </a:r>
                      <a:r>
                        <a:rPr lang="en-US" sz="120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  <a:sym typeface="+mn-ea"/>
                        </a:rPr>
                        <a:t>mM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alt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1.0</a:t>
                      </a:r>
                      <a:r>
                        <a:rPr lang="en-US" sz="120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  <a:sym typeface="+mn-ea"/>
                        </a:rPr>
                        <a:t> </a:t>
                      </a:r>
                      <a:r>
                        <a:rPr lang="en-US" sz="120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  <a:sym typeface="+mn-ea"/>
                        </a:rPr>
                        <a:t>mM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alt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1.5</a:t>
                      </a:r>
                      <a:r>
                        <a:rPr lang="en-US" sz="120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  <a:sym typeface="+mn-ea"/>
                        </a:rPr>
                        <a:t> </a:t>
                      </a:r>
                      <a:r>
                        <a:rPr lang="en-US" sz="120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  <a:sym typeface="+mn-ea"/>
                        </a:rPr>
                        <a:t>mM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alt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2.0</a:t>
                      </a:r>
                      <a:r>
                        <a:rPr lang="en-US" sz="120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  <a:sym typeface="+mn-ea"/>
                        </a:rPr>
                        <a:t> </a:t>
                      </a:r>
                      <a:r>
                        <a:rPr lang="en-US" sz="120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  <a:sym typeface="+mn-ea"/>
                        </a:rPr>
                        <a:t>mM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 fontAlgn="auto">
                        <a:buNone/>
                      </a:pPr>
                      <a:r>
                        <a:rPr lang="en-US" alt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2.5</a:t>
                      </a:r>
                      <a:r>
                        <a:rPr lang="en-US" sz="120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  <a:sym typeface="+mn-ea"/>
                        </a:rPr>
                        <a:t> </a:t>
                      </a:r>
                      <a:r>
                        <a:rPr lang="en-US" sz="120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  <a:sym typeface="+mn-ea"/>
                        </a:rPr>
                        <a:t>mM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291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LA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69.90±0.16 a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45.40±0.73 c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35.97±0.21 c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30.07±0.29 d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24.47±1.68 c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22.57±0.50 c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227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GML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69.90±0.16 a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50.80±0.86 b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44.47±0.94 b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39.00±0.57 c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37.17±0.17 b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23.47±1.03 c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164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MEL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69.90±0.16 a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57.53±0.58 a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55.03±0.69 a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54.60±0.83 a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50.70±0.78 a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49.97±0.25 a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2227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ETL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69.90±0.16 a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57.37±0.74 a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54.43±0.68 a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51.47±0.98 b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50.60±0.54 a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45.47±1.40 b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2028825" y="4256405"/>
            <a:ext cx="8134350" cy="4603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Note: Values within columns followed by the same letter for each parameter are not significantly different from each other based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on ANOVA and Fisher’s protected LSD test (p &lt; 0.05).</a:t>
            </a:r>
            <a:endParaRPr lang="zh-CN" altLang="en-US" sz="120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文本框 1"/>
          <p:cNvSpPr txBox="1"/>
          <p:nvPr/>
        </p:nvSpPr>
        <p:spPr>
          <a:xfrm>
            <a:off x="2337435" y="188595"/>
            <a:ext cx="7901305" cy="30670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266700"/>
            <a:r>
              <a:rPr lang="en-US" sz="1400" b="0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Supplementary Table.3 Effect of lauric acid and its derivatives on zoosporangium and zoosporium.</a:t>
            </a:r>
            <a:r>
              <a:rPr lang="en-US" sz="1050" b="0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</a:t>
            </a:r>
            <a:endParaRPr lang="zh-CN" altLang="en-US"/>
          </a:p>
        </p:txBody>
      </p:sp>
      <p:graphicFrame>
        <p:nvGraphicFramePr>
          <p:cNvPr id="6" name="表格 5"/>
          <p:cNvGraphicFramePr/>
          <p:nvPr>
            <p:custDataLst>
              <p:tags r:id="rId1"/>
            </p:custDataLst>
          </p:nvPr>
        </p:nvGraphicFramePr>
        <p:xfrm>
          <a:off x="3391535" y="741680"/>
          <a:ext cx="5516245" cy="558482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431800"/>
                <a:gridCol w="941705"/>
                <a:gridCol w="960120"/>
                <a:gridCol w="1136015"/>
                <a:gridCol w="916305"/>
                <a:gridCol w="1130300"/>
              </a:tblGrid>
              <a:tr h="441960">
                <a:tc>
                  <a:txBody>
                    <a:bodyPr/>
                    <a:p>
                      <a:pPr indent="0" algn="ctr">
                        <a:buNone/>
                      </a:pP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oncentration（mM）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Zoosporangium number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Zoosporangium </a:t>
                      </a: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   </a:t>
                      </a: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inhibition rate</a:t>
                      </a: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     </a:t>
                      </a: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（%）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Zoospores </a:t>
                      </a: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   </a:t>
                      </a: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number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Zoospores</a:t>
                      </a: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        </a:t>
                      </a: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 inhibition rate     （%）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K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00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7.2±5.6 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-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47.0±1.6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-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L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0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9.0±3.0 a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-6.3±11.1 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44.0±3.6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.2±2.0 f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0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3.8±5.3 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.5±21.0 d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33.0±5.9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.6±2.3 d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049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0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4.6±6.3 c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0.6±25.6 c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18.0±15.6 a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1.8±5.7 d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0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5.2±5.5 d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8.6±14.1 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03.3±7.4 c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8.2±2.7 bc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1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8.6±3.6 d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6.1±11.6 a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6.0±7.9 d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9.2±3.4 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3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8.2±5.6 d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8.8±14.7 a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0.3±2.1 d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1.5±0.9 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6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±0.0 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00.0±0.0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±0.0 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00.0±0.0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1.28</a:t>
                      </a:r>
                      <a:endParaRPr lang="en-US" altLang="en-US" sz="10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±0.0 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00.0±0.0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±0.0 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00.0±0.0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653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ML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0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3.4±4.3 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7.4±10.8 d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40.7±15.1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.6±5.6 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0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9.0±2.8 bc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0.9±9.7 cd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44.7±4.9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9±1.8 f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0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8.2±3.8 d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0.0±11.9 bc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1.0±6.4 d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1.2±2.8 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0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0.8±3.4 d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0.0±11.3 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7.3±1.7 d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6.8±0.6 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1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.0±3.7 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88.4±11.3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5.7±1.7 d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85.5±0.6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3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6±0.8 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98.5±2.0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.0±0.8 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99.6±0.3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6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±0.0 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00.0±0.0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±0.0 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00.0±0.0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1.28</a:t>
                      </a:r>
                      <a:endParaRPr lang="en-US" altLang="en-US" sz="10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±0.0 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00.0±0.0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0±0.0 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00.0±0.0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653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EL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0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7.8±7.5 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-5.2±31.7 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40.7±11.3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.5±5.2 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0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7.6±7.2 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-4.3±27.7 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47.7±16.4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-0.2±6.0 f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478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0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5.2±8.2 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.1±29.5 d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21.7±16.4 a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0.3±6.1 d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0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7.0±5.8 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-0.1±14.0 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97.0±17.4 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0.3±6.5 cd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1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1.0±10.1 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.4±36.7 d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94.7±5.8 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1.2±2.6 cd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3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9.4±5.9 bc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9.4±25.3 d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11.7±18.4 c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4.8±7.1 bc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6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4.4±3.7 c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3.1±13.1 c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8.0±12.1 d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88.7±4.9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1.28</a:t>
                      </a:r>
                      <a:endParaRPr lang="en-US" altLang="en-US" sz="10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3.6±6.5 d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1.2±20.5 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6.7±17.3 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93.3±6.9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ETL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01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3.0±5.1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-21.8±41.4 f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50.0±7.8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-1.2±3.5 f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0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0.6±9.0 a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-13.6±43.0 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45.7±6.2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6±1.9 f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0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0.8±3.3 a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-11.9±21.1 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45.7±5.0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5±1.4 f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08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3.6±4.6 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8.9±14.1 d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98.3±13.9 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9.7±6.2 cd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160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16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8.0±3.2 bc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2.6±19.1 cd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50.7±15.3 bc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9.0±6.5 c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32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5.2±6.3 c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9.1±26.0 c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14.0±15.3 c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3.8±6.5 bc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64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6.6±4.6 d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6.0±8.8 bc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81.0±15.1 d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7.2±6.1 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3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0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1.28</a:t>
                      </a:r>
                      <a:endParaRPr lang="en-US" altLang="en-US" sz="10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4.2±4.9 d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1.0±13.8 b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0.3±19.5 de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0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87.7±7.9 a</a:t>
                      </a:r>
                      <a:endParaRPr lang="en-US" altLang="en-US" sz="10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00" name="文本框 99"/>
          <p:cNvSpPr txBox="1"/>
          <p:nvPr/>
        </p:nvSpPr>
        <p:spPr>
          <a:xfrm>
            <a:off x="2819400" y="3925570"/>
            <a:ext cx="5307965" cy="39878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sz="1000" b="0">
                <a:latin typeface="Times New Roman" panose="02020603050405020304" charset="0"/>
                <a:ea typeface="宋体" panose="02010600030101010101" pitchFamily="2" charset="-122"/>
              </a:rPr>
              <a:t>Note:The percentage of colony area</a:t>
            </a:r>
            <a:r>
              <a:rPr lang="en-US" sz="1000" b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</a:t>
            </a:r>
            <a:r>
              <a:rPr lang="en-US" sz="1000" b="0">
                <a:latin typeface="Times New Roman" panose="02020603050405020304" charset="0"/>
                <a:ea typeface="宋体" panose="02010600030101010101" pitchFamily="2" charset="-122"/>
              </a:rPr>
              <a:t>: “-”:0%, “+”:1%-25%, “++”:25%-50%,“ +++”:50%-75%, “++++”:75%-100%.</a:t>
            </a:r>
            <a:endParaRPr lang="en-US" altLang="en-US" sz="1000" b="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graphicFrame>
        <p:nvGraphicFramePr>
          <p:cNvPr id="5" name="表格 4"/>
          <p:cNvGraphicFramePr/>
          <p:nvPr>
            <p:custDataLst>
              <p:tags r:id="rId1"/>
            </p:custDataLst>
          </p:nvPr>
        </p:nvGraphicFramePr>
        <p:xfrm>
          <a:off x="2446973" y="1402080"/>
          <a:ext cx="6540500" cy="231267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18210"/>
                <a:gridCol w="702310"/>
                <a:gridCol w="702945"/>
                <a:gridCol w="702945"/>
                <a:gridCol w="702945"/>
                <a:gridCol w="702945"/>
                <a:gridCol w="702310"/>
                <a:gridCol w="702945"/>
                <a:gridCol w="702945"/>
              </a:tblGrid>
              <a:tr h="385445">
                <a:tc row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T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reatment</a:t>
                      </a:r>
                      <a:endParaRPr lang="en-US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  <a:p>
                      <a:pPr indent="0" algn="ctr">
                        <a:buNone/>
                      </a:pPr>
                      <a:r>
                        <a:rPr lang="en-US" altLang="zh-CN" sz="900"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 </a:t>
                      </a:r>
                      <a:endParaRPr lang="en-US" sz="9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8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Concentration (</a:t>
                      </a: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mM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)</a:t>
                      </a:r>
                      <a:endParaRPr lang="en-US" altLang="en-US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  <a:tc hMerge="1">
                  <a:tcPr>
                    <a:lnR cap="flat"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</a:tcPr>
                </a:tc>
              </a:tr>
              <a:tr h="385445">
                <a:tc vMerge="1"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0.00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0.02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0.0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4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0.0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8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0.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16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0.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32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0.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64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1</a:t>
                      </a: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.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2</a:t>
                      </a: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8</a:t>
                      </a:r>
                      <a:endParaRPr lang="en-US" altLang="en-US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8544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L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A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+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+++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+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+++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+</a:t>
                      </a:r>
                      <a:endParaRPr lang="en-US" altLang="en-US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-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-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-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-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-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8544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GML</a:t>
                      </a:r>
                      <a:endParaRPr lang="en-US" altLang="en-US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+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+++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+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+++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+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+++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-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-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-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-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-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8544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M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EL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+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+++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+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+++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+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+++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+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+++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+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+++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+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+++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+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+++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+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++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8544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E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TL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+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+++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+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+++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+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+++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+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+++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+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+++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+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+++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+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+++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+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++</a:t>
                      </a:r>
                      <a:endParaRPr lang="en-US" altLang="en-US" sz="12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6" name="文本框 5"/>
          <p:cNvSpPr txBox="1"/>
          <p:nvPr/>
        </p:nvSpPr>
        <p:spPr>
          <a:xfrm>
            <a:off x="2145030" y="975360"/>
            <a:ext cx="7901305" cy="30670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266700"/>
            <a:r>
              <a:rPr lang="en-US" sz="1400" b="0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Supplementary Table.4 Effect of lauric acid and its derivatives on the germination of zoospores</a:t>
            </a:r>
            <a:endParaRPr lang="en-US" sz="1400" b="0">
              <a:solidFill>
                <a:srgbClr val="333333"/>
              </a:solidFill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00" name="文本框 99"/>
          <p:cNvSpPr txBox="1"/>
          <p:nvPr/>
        </p:nvSpPr>
        <p:spPr>
          <a:xfrm>
            <a:off x="2221230" y="247650"/>
            <a:ext cx="8037830" cy="30670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266700"/>
            <a:r>
              <a:rPr lang="en-US" sz="1050" b="0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</a:rPr>
              <a:t> </a:t>
            </a:r>
            <a:r>
              <a:rPr lang="en-US" sz="1400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Supplementary Table.5</a:t>
            </a:r>
            <a:r>
              <a:rPr lang="en-US" sz="1400" b="0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</a:t>
            </a:r>
            <a:r>
              <a:rPr lang="en-US" sz="1400" b="0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</a:rPr>
              <a:t>Safety of lauric acid and its derivatives on soybean plants.</a:t>
            </a:r>
            <a:endParaRPr lang="en-US" altLang="en-US" sz="1400" b="0">
              <a:solidFill>
                <a:srgbClr val="333333"/>
              </a:solidFill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graphicFrame>
        <p:nvGraphicFramePr>
          <p:cNvPr id="2" name="表格 1"/>
          <p:cNvGraphicFramePr/>
          <p:nvPr>
            <p:custDataLst>
              <p:tags r:id="rId1"/>
            </p:custDataLst>
          </p:nvPr>
        </p:nvGraphicFramePr>
        <p:xfrm>
          <a:off x="2084388" y="734060"/>
          <a:ext cx="8407400" cy="53162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34770"/>
                <a:gridCol w="1335405"/>
                <a:gridCol w="1336040"/>
                <a:gridCol w="1334770"/>
                <a:gridCol w="1022350"/>
                <a:gridCol w="1022985"/>
                <a:gridCol w="1021080"/>
              </a:tblGrid>
              <a:tr h="495935">
                <a:tc row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Concentration</a:t>
                      </a:r>
                      <a:endParaRPr lang="en-US" altLang="zh-CN" sz="1200">
                        <a:latin typeface="Times New Roman" panose="02020603050405020304" charset="0"/>
                        <a:cs typeface="Times New Roman" panose="02020603050405020304" charset="0"/>
                        <a:sym typeface="+mn-ea"/>
                      </a:endParaRPr>
                    </a:p>
                    <a:p>
                      <a:pPr indent="0" algn="ctr">
                        <a:buNone/>
                      </a:pPr>
                      <a:r>
                        <a:rPr lang="en-US" altLang="zh-CN" sz="12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 (</a:t>
                      </a:r>
                      <a:r>
                        <a:rPr lang="en-US" altLang="zh-CN" sz="120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  <a:sym typeface="Arial" panose="020B0604020202020204" pitchFamily="34" charset="0"/>
                        </a:rPr>
                        <a:t>g a.i./plant</a:t>
                      </a:r>
                      <a:r>
                        <a:rPr lang="en-US" altLang="zh-CN" sz="1200"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)</a:t>
                      </a:r>
                      <a:endParaRPr lang="en-US" sz="9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Days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  <a:p>
                      <a:pPr indent="0" algn="ctr">
                        <a:buNone/>
                      </a:pPr>
                      <a:r>
                        <a:rPr lang="en-US" alt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(d)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5">
                  <a:txBody>
                    <a:bodyPr/>
                    <a:p>
                      <a:pPr indent="0" algn="ctr">
                        <a:buNone/>
                      </a:pPr>
                      <a:r>
                        <a:rPr sz="1200">
                          <a:latin typeface="Times New Roman" panose="02020603050405020304" charset="0"/>
                          <a:cs typeface="Times New Roman" panose="02020603050405020304" charset="0"/>
                        </a:rPr>
                        <a:t>Plant height (cm) at different concentrations of lauric acid and its derivatives</a:t>
                      </a:r>
                      <a:endParaRPr sz="120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 marL="68580" marR="68580" marT="0" marB="0" vert="horz" anchor="ctr" anchorCtr="0">
                    <a:lnL>
                      <a:noFill/>
                    </a:lnL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cP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>
                      <a:solidFill>
                        <a:schemeClr val="tx1"/>
                      </a:solidFill>
                      <a:prstDash val="solid"/>
                    </a:lnB>
                  </a:tcPr>
                </a:tc>
                <a:tc hMerge="1">
                  <a:tcPr>
                    <a:lnR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>
                      <a:solidFill>
                        <a:schemeClr val="tx1"/>
                      </a:solidFill>
                      <a:prstDash val="solid"/>
                    </a:lnB>
                  </a:tcPr>
                </a:tc>
              </a:tr>
              <a:tr h="484505">
                <a:tc vMerge="1"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CK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6350">
                      <a:solidFill>
                        <a:schemeClr val="tx1"/>
                      </a:solidFill>
                      <a:prstDash val="soli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LA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6350">
                      <a:solidFill>
                        <a:schemeClr val="tx1"/>
                      </a:solidFill>
                      <a:prstDash val="soli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GML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6350">
                      <a:solidFill>
                        <a:schemeClr val="tx1"/>
                      </a:solidFill>
                      <a:prstDash val="soli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MEL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6350">
                      <a:solidFill>
                        <a:schemeClr val="tx1"/>
                      </a:solidFill>
                      <a:prstDash val="soli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ETL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6350">
                      <a:solidFill>
                        <a:schemeClr val="tx1"/>
                      </a:solidFill>
                      <a:prstDash val="soli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537845">
                <a:tc row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1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7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19.73±0.55 a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21.01±0.75 a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20.82±1.27 a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22.73±0.85 a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23.47±1.47 a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543560">
                <a:tc vMerge="1"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14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33.25±1.11 a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34.94±1.98 a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33.72±2.11 a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32.46±1.84 a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34.88±3.11 a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537845">
                <a:tc row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3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7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19.73±0.55 a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19.79±1.04 a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20.74±1.17 a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19.64±1.05 a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19.93±1.79 a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544830">
                <a:tc vMerge="1"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14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33.25±1.11 a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33.41±1.76 a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33.58±2.03 a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34.95±0.89 a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32.86±4.19 a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536575">
                <a:tc row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6</a:t>
                      </a:r>
                      <a:endParaRPr 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7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19.73±0.55 a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17.41±1.76 b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17.45±1.98 b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19.27±1.31 a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19.79±1.46 a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544830">
                <a:tc vMerge="1"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14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33.25±1.11 a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27.51±0.73 b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22.36±1.83 b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33.61±3.53 a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30.92±2.39 ab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545465">
                <a:tc rowSpan="2"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0.9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7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19.73±0.55 a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12.47±1.18 c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12.71±1.37 c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18.39±1.64 b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18.98±1.37 b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544830">
                <a:tc vMerge="1"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14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33.25±1.11 a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19.04±1.14 c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18.78±1.10 c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29.12±1.32 b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  <a:sym typeface="+mn-ea"/>
                        </a:rPr>
                        <a:t>30.48±0.97 b</a:t>
                      </a:r>
                      <a:endParaRPr lang="en-US" altLang="en-US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  <a:sym typeface="+mn-ea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>
                      <a:solidFill>
                        <a:schemeClr val="tx1"/>
                      </a:solidFill>
                      <a:prstDash val="soli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2221230" y="6229985"/>
            <a:ext cx="8134350" cy="4603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Note: Values within columns followed by the same letter for each parameter are not significantly different from each other based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on ANOVA and Fisher’s protected LSD test (p &lt; 0.05).</a:t>
            </a:r>
            <a:endParaRPr lang="zh-CN" altLang="en-US" sz="120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4" name="表格 3"/>
          <p:cNvGraphicFramePr/>
          <p:nvPr>
            <p:custDataLst>
              <p:tags r:id="rId1"/>
            </p:custDataLst>
          </p:nvPr>
        </p:nvGraphicFramePr>
        <p:xfrm>
          <a:off x="2418397" y="1281430"/>
          <a:ext cx="7559675" cy="320421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89125"/>
                <a:gridCol w="1889125"/>
                <a:gridCol w="1889125"/>
                <a:gridCol w="1892300"/>
              </a:tblGrid>
              <a:tr h="534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Treatment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Incidence(%)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Disease index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Control effect(%)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534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CK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100.00±0.00 a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86.67±6.54 a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/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534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LA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40.74±10.48 c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17.04±6.87 d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76.40±8.23 a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534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GML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37.03±5.24 d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29.63±5.24 </a:t>
                      </a:r>
                      <a:r>
                        <a:rPr lang="en-US" sz="1600" b="0">
                          <a:latin typeface="宋体" panose="02010600030101010101" pitchFamily="2" charset="-122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d</a:t>
                      </a:r>
                      <a:endParaRPr lang="en-US" altLang="en-US" sz="1600" b="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65.48±7.34 b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534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MEL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62.97±5.24 b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4.82±4.19 b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36.27±7.98 c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534035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ETL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1.85±5.24 c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40.74±2.09 c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6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52.90±1.39 b</a:t>
                      </a:r>
                      <a:endParaRPr lang="en-US" altLang="en-US" sz="16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 anchorCtr="0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905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5" name="文本框 4"/>
          <p:cNvSpPr txBox="1"/>
          <p:nvPr/>
        </p:nvSpPr>
        <p:spPr>
          <a:xfrm>
            <a:off x="3088005" y="741680"/>
            <a:ext cx="6393815" cy="36830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algn="l"/>
            <a:r>
              <a:rPr lang="en-US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 </a:t>
            </a:r>
            <a:r>
              <a:rPr lang="en-US" sz="1400">
                <a:solidFill>
                  <a:srgbClr val="333333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Supplementary Table.6 Effect of lauric acid and its derivatives on soybean rhizome rot</a:t>
            </a:r>
            <a:endParaRPr lang="en-US" sz="1400">
              <a:solidFill>
                <a:srgbClr val="333333"/>
              </a:solidFill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TABLE_BEAUTIFY" val="smartTable{eaacea02-7c15-4c4b-bc77-4df2766fee8e}"/>
  <p:tag name="TABLE_ENDDRAG_ORIGIN_RECT" val="587*195"/>
  <p:tag name="TABLE_ENDDRAG_RECT" val="162*139*587*195"/>
</p:tagLst>
</file>

<file path=ppt/tags/tag2.xml><?xml version="1.0" encoding="utf-8"?>
<p:tagLst xmlns:p="http://schemas.openxmlformats.org/presentationml/2006/main">
  <p:tag name="KSO_WM_UNIT_TABLE_BEAUTIFY" val="smartTable{4853c818-c205-468a-9ca8-2beba036ee36}"/>
  <p:tag name="TABLE_ENDDRAG_ORIGIN_RECT" val="629*193"/>
  <p:tag name="TABLE_ENDDRAG_RECT" val="159*136*629*193"/>
</p:tagLst>
</file>

<file path=ppt/tags/tag3.xml><?xml version="1.0" encoding="utf-8"?>
<p:tagLst xmlns:p="http://schemas.openxmlformats.org/presentationml/2006/main">
  <p:tag name="KSO_WM_UNIT_TABLE_BEAUTIFY" val="smartTable{a5b0490a-5089-4a8c-8c9e-32bc36ac99e4}"/>
</p:tagLst>
</file>

<file path=ppt/tags/tag4.xml><?xml version="1.0" encoding="utf-8"?>
<p:tagLst xmlns:p="http://schemas.openxmlformats.org/presentationml/2006/main">
  <p:tag name="KSO_WM_UNIT_TABLE_BEAUTIFY" val="smartTable{eaacea02-7c15-4c4b-bc77-4df2766fee8e}"/>
  <p:tag name="TABLE_ENDDRAG_ORIGIN_RECT" val="515*181"/>
  <p:tag name="TABLE_ENDDRAG_RECT" val="185*69*515*181"/>
</p:tagLst>
</file>

<file path=ppt/tags/tag5.xml><?xml version="1.0" encoding="utf-8"?>
<p:tagLst xmlns:p="http://schemas.openxmlformats.org/presentationml/2006/main">
  <p:tag name="KSO_WM_UNIT_TABLE_BEAUTIFY" val="smartTable{4853c818-c205-468a-9ca8-2beba036ee36}"/>
  <p:tag name="TABLE_ENDDRAG_ORIGIN_RECT" val="662*418"/>
  <p:tag name="TABLE_ENDDRAG_RECT" val="164*57*662*418"/>
</p:tagLst>
</file>

<file path=ppt/tags/tag6.xml><?xml version="1.0" encoding="utf-8"?>
<p:tagLst xmlns:p="http://schemas.openxmlformats.org/presentationml/2006/main">
  <p:tag name="KSO_WM_UNIT_TABLE_BEAUTIFY" val="smartTable{f360a1b2-3d51-4135-bf37-7783ad0aa5d8}"/>
  <p:tag name="TABLE_ENDDRAG_ORIGIN_RECT" val="595*252"/>
  <p:tag name="TABLE_ENDDRAG_RECT" val="190*100*595*252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179</Words>
  <Application>WPS 演示</Application>
  <PresentationFormat>宽屏</PresentationFormat>
  <Paragraphs>898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5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ell</dc:creator>
  <cp:lastModifiedBy>群青✨</cp:lastModifiedBy>
  <cp:revision>20</cp:revision>
  <dcterms:created xsi:type="dcterms:W3CDTF">2021-05-06T07:41:00Z</dcterms:created>
  <dcterms:modified xsi:type="dcterms:W3CDTF">2021-06-22T03:41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BD6438638DC4A03A3688A0D89A0F63D</vt:lpwstr>
  </property>
  <property fmtid="{D5CDD505-2E9C-101B-9397-08002B2CF9AE}" pid="3" name="KSOProductBuildVer">
    <vt:lpwstr>2052-11.1.0.10495</vt:lpwstr>
  </property>
</Properties>
</file>